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1D8568-1924-4948-B0E3-D2A6224B42A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9E7E2A9-D0E1-4C73-B6F5-8D099B77AD5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C2BEC4-B4AE-4ECB-8C2F-0D17CEFDD6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FD0CE-B741-416F-9B16-351C3E56789B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174299-E438-4FD2-A29E-33F959FDB6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878D49-FC51-43A0-BFF7-9561E50CD3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3EA793-5440-4828-BA3B-E02227182DED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5253175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BD316A-0E71-4600-98B9-553ED53D72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C7531C9-582D-449E-A636-D699642D070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BC75C6-9A4C-4003-9F4F-E5DB46EEB1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FD0CE-B741-416F-9B16-351C3E56789B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1A21F7-D8E4-4D9E-82E3-A04BB7FF57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ADFB26-3A30-4CAD-AD08-8AD7C3274C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3EA793-5440-4828-BA3B-E02227182DED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16364473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C6E56CB-8660-4A54-AE95-340573E1252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9FE5ECB-66E8-4523-A9DE-DD21CDA8A28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53C05F-9A8B-48FC-A1AC-AD73E1EBDF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FD0CE-B741-416F-9B16-351C3E56789B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C8982D-26E3-40CF-8709-2E9B92512D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DF0BF8-654E-45F4-9B15-3E83298A76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3EA793-5440-4828-BA3B-E02227182DED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31121279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D5EC4C-F098-44BD-85F8-8DF64CC189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8828B4-8CCB-4F22-9370-CD7A13AE348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16B7F2-051F-44EF-BB31-CDB34415C3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FD0CE-B741-416F-9B16-351C3E56789B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E7D962-6F64-44BB-8AE0-D8E00D60E4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D7AEB8-5ECA-4D02-883B-10AC39F2C9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3EA793-5440-4828-BA3B-E02227182DED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26347201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7E470D-65A8-4260-9FF3-7F4687EADF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266B154-E772-4322-B195-8EB92A73B0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7AB76F-E211-4681-A893-FBE149A1F1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FD0CE-B741-416F-9B16-351C3E56789B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90EB39-DA21-4DCB-8023-9E8514F04F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7B53E2-A174-49E0-85EA-F8B26FF5DE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3EA793-5440-4828-BA3B-E02227182DED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34386078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000CFC-9610-4F0F-A9F3-5070475432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56081BA-BD67-4443-AA65-7B8E2C51103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CC92F2B-F76D-41B6-8846-2530D5B64A9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69B0282-F87A-4D0A-A5D8-8DEEDD0462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FD0CE-B741-416F-9B16-351C3E56789B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070091B-0920-45CF-98FD-AB9B4F587B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3E7BB70-5F18-4268-8F14-235C2479EB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3EA793-5440-4828-BA3B-E02227182DED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4342306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83CCA3-78C3-44F8-9BA9-A3BDC40953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7970723-05FF-423D-B695-D1576929BC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8792AA3-16DA-4AD0-B6E7-BC960CCFC9E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6FA5F0C-7F8D-49D7-97A4-78691914C46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ABB0D77-2945-468A-BD20-A780971EDF7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6158592-3BC8-4655-A46E-F80188B37A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FD0CE-B741-416F-9B16-351C3E56789B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0A858E3-2FF4-40FD-8E49-B08E073E14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2D53474-F3E0-4E5E-8905-14A024F706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3EA793-5440-4828-BA3B-E02227182DED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9392175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8C35F7-7310-4C00-9130-B35555C905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344B8A7-73C6-499D-AB57-C2535F5ECC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FD0CE-B741-416F-9B16-351C3E56789B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679CA33-6D08-4073-B821-AACF7D6BF4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41C3F22-123D-4EA4-913F-A4F0C4F8F1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3EA793-5440-4828-BA3B-E02227182DED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12407119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38B7846-80D7-45AC-83E4-F263FC3787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FD0CE-B741-416F-9B16-351C3E56789B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FD0A49F-C021-4506-931B-9805610CAE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4899E5F-FDA7-4F7E-959E-C55EAB1E70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3EA793-5440-4828-BA3B-E02227182DED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11776969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0B6909-EDA6-4CF6-8E7D-69A243E82A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FCA76B8-B204-41F8-91DD-507C824159A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40AC621-3C6E-4668-B957-1C253752A8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DD646AD-4323-492D-BCC3-4AFF8DD566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FD0CE-B741-416F-9B16-351C3E56789B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43E9261-3748-41B1-8871-41390B2F8A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CA8EBDB-69E0-4569-9A51-EAB11785A8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3EA793-5440-4828-BA3B-E02227182DED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17220753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A02B5F-AAD7-4C4C-B00B-AC681C324F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8422B5C-E77D-4A8C-BB53-A925168DDFB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D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01D28D7-E1A0-4A7D-A6CA-7E28D0A320C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05D0410-0B0C-422E-8007-DBE45C9286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FD0CE-B741-416F-9B16-351C3E56789B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7469C34-46FD-4FFE-8A4E-D4F290F70B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D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34BF468-0F61-461A-B97A-0E9D2F8633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3EA793-5440-4828-BA3B-E02227182DED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13896561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D619A56-5A56-478A-8E8C-2909D235EF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D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31285C-9C2B-4229-B9A5-D38FCEA977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8F4BE5-9A20-4222-97F7-A877BA39337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5FD0CE-B741-416F-9B16-351C3E56789B}" type="datetimeFigureOut">
              <a:rPr lang="en-ID" smtClean="0"/>
              <a:t>24/07/2022</a:t>
            </a:fld>
            <a:endParaRPr lang="en-ID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A5FDCC-1C68-4D28-9497-E8F1D7364C3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D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D91B07-CA04-423A-BA91-56941459489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3EA793-5440-4828-BA3B-E02227182DED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39890278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CEEC7F5-6F9A-454E-8727-02C416F0AF1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05637" y="1190624"/>
            <a:ext cx="7466201" cy="4935463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1D0D123E-1523-C31D-B0FB-936F82BF2ED1}"/>
              </a:ext>
            </a:extLst>
          </p:cNvPr>
          <p:cNvSpPr txBox="1"/>
          <p:nvPr/>
        </p:nvSpPr>
        <p:spPr>
          <a:xfrm>
            <a:off x="3749878" y="1979802"/>
            <a:ext cx="58219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able 3a. Reference range of WBC, RBC, HGB, HCT, MCV, MCH, MCHC for healthy girl babies aged 1-4 months</a:t>
            </a:r>
          </a:p>
        </p:txBody>
      </p:sp>
    </p:spTree>
    <p:extLst>
      <p:ext uri="{BB962C8B-B14F-4D97-AF65-F5344CB8AC3E}">
        <p14:creationId xmlns:p14="http://schemas.microsoft.com/office/powerpoint/2010/main" val="15955207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3CC205E-F1B3-4871-BFEB-19F11DB3287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37619" y="740328"/>
            <a:ext cx="9706471" cy="537734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E25F750-A33D-B1DF-1830-2DCA1076B623}"/>
              </a:ext>
            </a:extLst>
          </p:cNvPr>
          <p:cNvSpPr txBox="1"/>
          <p:nvPr/>
        </p:nvSpPr>
        <p:spPr>
          <a:xfrm>
            <a:off x="2902369" y="2139193"/>
            <a:ext cx="657696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able 3b. Reference range of PLT, RDW SD, RDW CV, PDW, MPV, PCT, neutrophil, lymphocyte for healthy girl babies aged 1-4 months</a:t>
            </a:r>
          </a:p>
        </p:txBody>
      </p:sp>
    </p:spTree>
    <p:extLst>
      <p:ext uri="{BB962C8B-B14F-4D97-AF65-F5344CB8AC3E}">
        <p14:creationId xmlns:p14="http://schemas.microsoft.com/office/powerpoint/2010/main" val="18824659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65E725B-89CD-4E9C-893E-6812FA989CF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9210" y="1057012"/>
            <a:ext cx="9797753" cy="5050173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35CEE6C-3182-3269-346C-821016AF525E}"/>
              </a:ext>
            </a:extLst>
          </p:cNvPr>
          <p:cNvSpPr txBox="1"/>
          <p:nvPr/>
        </p:nvSpPr>
        <p:spPr>
          <a:xfrm>
            <a:off x="2718032" y="1971413"/>
            <a:ext cx="778498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D" dirty="0"/>
              <a:t>Table 3c. Reference range of monocyte, eosinophil, eosinophil </a:t>
            </a:r>
            <a:r>
              <a:rPr lang="en-ID" dirty="0" err="1"/>
              <a:t>absolut</a:t>
            </a:r>
            <a:r>
              <a:rPr lang="en-ID" dirty="0"/>
              <a:t>, basophil, basophil </a:t>
            </a:r>
            <a:r>
              <a:rPr lang="en-ID" dirty="0" err="1"/>
              <a:t>absolut</a:t>
            </a:r>
            <a:r>
              <a:rPr lang="en-ID" dirty="0"/>
              <a:t>, IPF, IG, IRF for healthy girl babies aged 1-4 months</a:t>
            </a:r>
          </a:p>
        </p:txBody>
      </p:sp>
    </p:spTree>
    <p:extLst>
      <p:ext uri="{BB962C8B-B14F-4D97-AF65-F5344CB8AC3E}">
        <p14:creationId xmlns:p14="http://schemas.microsoft.com/office/powerpoint/2010/main" val="40181316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8DC0EC9-3892-492E-BF0F-F129C9F450A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42535" y="624359"/>
            <a:ext cx="5964571" cy="5609281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053C51D-D0FE-AC42-14FC-F0E61BADE16D}"/>
              </a:ext>
            </a:extLst>
          </p:cNvPr>
          <p:cNvSpPr txBox="1"/>
          <p:nvPr/>
        </p:nvSpPr>
        <p:spPr>
          <a:xfrm>
            <a:off x="4370663" y="1409350"/>
            <a:ext cx="456361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D" dirty="0"/>
              <a:t>Table 3d. Reference range of RPI, reticulocyte </a:t>
            </a:r>
            <a:r>
              <a:rPr lang="en-ID" dirty="0" err="1"/>
              <a:t>hemoglobin</a:t>
            </a:r>
            <a:r>
              <a:rPr lang="en-ID" dirty="0"/>
              <a:t>, reticulocyte </a:t>
            </a:r>
            <a:r>
              <a:rPr lang="en-ID" dirty="0" err="1"/>
              <a:t>hemoglobin</a:t>
            </a:r>
            <a:r>
              <a:rPr lang="en-ID" dirty="0"/>
              <a:t> %, reticulocyte </a:t>
            </a:r>
            <a:r>
              <a:rPr lang="en-ID" dirty="0" err="1"/>
              <a:t>hemoglobin</a:t>
            </a:r>
            <a:r>
              <a:rPr lang="en-ID" dirty="0"/>
              <a:t> in million for healthy girl babies aged 1-4 months</a:t>
            </a:r>
          </a:p>
        </p:txBody>
      </p:sp>
    </p:spTree>
    <p:extLst>
      <p:ext uri="{BB962C8B-B14F-4D97-AF65-F5344CB8AC3E}">
        <p14:creationId xmlns:p14="http://schemas.microsoft.com/office/powerpoint/2010/main" val="24868016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</TotalTime>
  <Words>111</Words>
  <Application>Microsoft Office PowerPoint</Application>
  <PresentationFormat>Widescreen</PresentationFormat>
  <Paragraphs>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rlindungan ringoringo</dc:creator>
  <cp:lastModifiedBy>parlindungan ringoringo</cp:lastModifiedBy>
  <cp:revision>3</cp:revision>
  <dcterms:created xsi:type="dcterms:W3CDTF">2022-02-16T21:33:35Z</dcterms:created>
  <dcterms:modified xsi:type="dcterms:W3CDTF">2022-07-23T22:28:31Z</dcterms:modified>
</cp:coreProperties>
</file>